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775FF-62B5-4AD0-B911-A3FA62FD5D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0450E-4CDE-4079-A166-83869A4599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62A6C-9E5C-4C06-9651-F9E7A0D7AC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1CA36-A3F6-4E31-81EC-8E05BE31B6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CF702-43B8-4966-86CA-45B82A1C6F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DEE507-3E00-44B5-BA25-BFC2F82989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214C3-F6A8-4DDD-B9F8-FA7193D78E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F985D-6D5B-4709-9F25-590D5995A3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B1847-848F-44FB-AF60-EFAA062B67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A0247-CDCD-4163-91A4-E128A3295E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51594D-B6BA-46C3-9C1E-C4346C7E6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B2B52-D6DF-4DF8-BF80-80055463CC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078B85-51D7-4F4D-B540-F25A5BAFEC0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523880" y="1371600"/>
            <a:ext cx="6858000" cy="4572000"/>
            <a:chOff x="1523880" y="1371600"/>
            <a:chExt cx="6858000" cy="4572000"/>
          </a:xfrm>
        </p:grpSpPr>
        <p:pic>
          <p:nvPicPr>
            <p:cNvPr id="42" name="Picture 3" descr=""/>
            <p:cNvPicPr/>
            <p:nvPr/>
          </p:nvPicPr>
          <p:blipFill>
            <a:blip r:embed="rId1"/>
            <a:stretch/>
          </p:blipFill>
          <p:spPr>
            <a:xfrm>
              <a:off x="1828800" y="1752480"/>
              <a:ext cx="4419720" cy="4191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3" name=""/>
            <p:cNvGrpSpPr/>
            <p:nvPr/>
          </p:nvGrpSpPr>
          <p:grpSpPr>
            <a:xfrm>
              <a:off x="1523880" y="1371600"/>
              <a:ext cx="6858000" cy="3962520"/>
              <a:chOff x="1523880" y="1371600"/>
              <a:chExt cx="6858000" cy="3962520"/>
            </a:xfrm>
          </p:grpSpPr>
          <p:sp>
            <p:nvSpPr>
              <p:cNvPr id="44" name=""/>
              <p:cNvSpPr/>
              <p:nvPr/>
            </p:nvSpPr>
            <p:spPr>
              <a:xfrm>
                <a:off x="4648320" y="1371600"/>
                <a:ext cx="228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nt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 rot="16200000">
                <a:off x="4762440" y="1486080"/>
                <a:ext cx="76320" cy="304560"/>
              </a:xfrm>
              <a:custGeom>
                <a:avLst/>
                <a:gdLst>
                  <a:gd name="textAreaLeft" fmla="*/ 0 w 76320"/>
                  <a:gd name="textAreaRight" fmla="*/ 27360 w 76320"/>
                  <a:gd name="textAreaTop" fmla="*/ 7920 h 304560"/>
                  <a:gd name="textAreaBottom" fmla="*/ 296640 h 304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900"/>
                      <a:pt x="10800" y="1800"/>
                    </a:cubicBezTo>
                    <a:lnTo>
                      <a:pt x="10800" y="9674"/>
                    </a:lnTo>
                    <a:cubicBezTo>
                      <a:pt x="10800" y="10574"/>
                      <a:pt x="16200" y="11474"/>
                      <a:pt x="21600" y="11474"/>
                    </a:cubicBezTo>
                    <a:cubicBezTo>
                      <a:pt x="16200" y="11474"/>
                      <a:pt x="10800" y="12374"/>
                      <a:pt x="10800" y="13274"/>
                    </a:cubicBezTo>
                    <a:lnTo>
                      <a:pt x="10800" y="19800"/>
                    </a:lnTo>
                    <a:cubicBezTo>
                      <a:pt x="10800" y="20700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523880" y="2057400"/>
                <a:ext cx="15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352680" y="1523880"/>
                <a:ext cx="990720" cy="381240"/>
              </a:xfrm>
              <a:prstGeom prst="wedgeRoundRectCallout">
                <a:avLst>
                  <a:gd name="adj1" fmla="val 81250"/>
                  <a:gd name="adj2" fmla="val 47083"/>
                  <a:gd name="adj3" fmla="val 16667"/>
                </a:avLst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gular 5'-MSD cleavage sit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523880" y="5029200"/>
                <a:ext cx="15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5334120" y="1523880"/>
                <a:ext cx="1295280" cy="381240"/>
              </a:xfrm>
              <a:prstGeom prst="wedgeRoundRectCallout">
                <a:avLst>
                  <a:gd name="adj1" fmla="val -78310"/>
                  <a:gd name="adj2" fmla="val 57083"/>
                  <a:gd name="adj3" fmla="val 16667"/>
                </a:avLst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ew 5'-MSD cleavage site in mutants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6629400" y="2286000"/>
                <a:ext cx="106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-type 5'-MS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6629400" y="4267080"/>
                <a:ext cx="990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utated 5'-MS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629400" y="3200400"/>
                <a:ext cx="990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utated 5'-MS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629400" y="5181480"/>
                <a:ext cx="1066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Wild-type 5'-MS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495680" y="2209680"/>
                <a:ext cx="685800" cy="0"/>
              </a:xfrm>
              <a:prstGeom prst="line">
                <a:avLst/>
              </a:prstGeom>
              <a:ln w="1908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495680" y="5181480"/>
                <a:ext cx="685800" cy="0"/>
              </a:xfrm>
              <a:prstGeom prst="line">
                <a:avLst/>
              </a:prstGeom>
              <a:ln w="1908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523880" y="4116240"/>
                <a:ext cx="15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523880" y="2971800"/>
                <a:ext cx="15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495680" y="3124080"/>
                <a:ext cx="685800" cy="0"/>
              </a:xfrm>
              <a:prstGeom prst="line">
                <a:avLst/>
              </a:prstGeom>
              <a:ln w="1908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7696080" y="2286000"/>
                <a:ext cx="152640" cy="1066680"/>
              </a:xfrm>
              <a:custGeom>
                <a:avLst/>
                <a:gdLst>
                  <a:gd name="textAreaLeft" fmla="*/ 0 w 152640"/>
                  <a:gd name="textAreaRight" fmla="*/ 55080 w 152640"/>
                  <a:gd name="textAreaTop" fmla="*/ 27720 h 1066680"/>
                  <a:gd name="textAreaBottom" fmla="*/ 1038960 h 10666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16200" y="10800"/>
                      <a:pt x="21600" y="10800"/>
                    </a:cubicBezTo>
                    <a:cubicBezTo>
                      <a:pt x="162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7696080" y="4267080"/>
                <a:ext cx="152640" cy="1067040"/>
              </a:xfrm>
              <a:custGeom>
                <a:avLst/>
                <a:gdLst>
                  <a:gd name="textAreaLeft" fmla="*/ 0 w 152640"/>
                  <a:gd name="textAreaRight" fmla="*/ 55080 w 152640"/>
                  <a:gd name="textAreaTop" fmla="*/ 27720 h 1067040"/>
                  <a:gd name="textAreaBottom" fmla="*/ 1039320 h 1067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900"/>
                      <a:pt x="10800" y="1800"/>
                    </a:cubicBezTo>
                    <a:lnTo>
                      <a:pt x="10800" y="9000"/>
                    </a:lnTo>
                    <a:cubicBezTo>
                      <a:pt x="10800" y="9900"/>
                      <a:pt x="16200" y="10800"/>
                      <a:pt x="21600" y="10800"/>
                    </a:cubicBezTo>
                    <a:cubicBezTo>
                      <a:pt x="16200" y="10800"/>
                      <a:pt x="10800" y="11700"/>
                      <a:pt x="10800" y="12600"/>
                    </a:cubicBezTo>
                    <a:lnTo>
                      <a:pt x="10800" y="19800"/>
                    </a:lnTo>
                    <a:cubicBezTo>
                      <a:pt x="10800" y="20700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7924680" y="2743200"/>
                <a:ext cx="457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JRCSF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7848720" y="4724280"/>
                <a:ext cx="304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V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495680" y="4191120"/>
                <a:ext cx="685800" cy="0"/>
              </a:xfrm>
              <a:prstGeom prst="line">
                <a:avLst/>
              </a:prstGeom>
              <a:ln w="1908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64" name=""/>
          <p:cNvSpPr/>
          <p:nvPr/>
        </p:nvSpPr>
        <p:spPr>
          <a:xfrm>
            <a:off x="1143000" y="762120"/>
            <a:ext cx="152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Suppl. Fig.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5T18:45:16Z</dcterms:created>
  <dc:creator>Research</dc:creator>
  <dc:description/>
  <dc:language>en-US</dc:language>
  <cp:lastModifiedBy>Gautam</cp:lastModifiedBy>
  <dcterms:modified xsi:type="dcterms:W3CDTF">2016-08-29T18:00:59Z</dcterms:modified>
  <cp:revision>27</cp:revision>
  <dc:subject/>
  <dc:title>Slide 1</dc:title>
</cp:coreProperties>
</file>